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81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7248" y="120"/>
      </p:cViewPr>
      <p:guideLst>
        <p:guide orient="horz" pos="384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547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6166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220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026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435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40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1706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4575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2418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154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1021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9914A-3919-47EE-B0B1-EF0ECC48F458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98A7F-DE46-4280-98E0-A1508C4CFC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1748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961DFD6-68CA-7878-4481-A4FFF93430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29" y="1246986"/>
            <a:ext cx="6601968" cy="857097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5A81C3E-F486-EA72-A478-ECF710C1F847}"/>
              </a:ext>
            </a:extLst>
          </p:cNvPr>
          <p:cNvSpPr txBox="1"/>
          <p:nvPr/>
        </p:nvSpPr>
        <p:spPr>
          <a:xfrm>
            <a:off x="525656" y="9817962"/>
            <a:ext cx="5879714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1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. Summary of R. </a:t>
            </a:r>
            <a:r>
              <a:rPr lang="en-US" altLang="zh-CN" sz="11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1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notations. (A)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Venn diagram summarizing the number of 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ith functional information extracted from four databases. Nr: NCBI non-redundant protein database, KEGG: the Kyoto Encyclopedia of Genes and Genomes database, KOG: Eukaryotic Orthologous Groups of proteins database. Swiss-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t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Swiss-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t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database.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OG functional classification of annotated 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Ontology classification of annotated 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or biological processes, cellular component and molecular function.</a:t>
            </a:r>
            <a:endParaRPr lang="zh-CN" altLang="zh-CN" sz="1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6972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9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3</cp:revision>
  <dcterms:created xsi:type="dcterms:W3CDTF">2022-07-17T12:50:58Z</dcterms:created>
  <dcterms:modified xsi:type="dcterms:W3CDTF">2023-01-10T11:17:58Z</dcterms:modified>
</cp:coreProperties>
</file>